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Total artic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Amikacin</c:v>
                </c:pt>
                <c:pt idx="1">
                  <c:v>Ampicillin</c:v>
                </c:pt>
                <c:pt idx="2">
                  <c:v>Cefepime</c:v>
                </c:pt>
                <c:pt idx="3">
                  <c:v>Ceftazidime</c:v>
                </c:pt>
                <c:pt idx="4">
                  <c:v>Ciprofloxacin</c:v>
                </c:pt>
                <c:pt idx="5">
                  <c:v>Daptomycin</c:v>
                </c:pt>
                <c:pt idx="6">
                  <c:v>Gentamicin</c:v>
                </c:pt>
                <c:pt idx="7">
                  <c:v>Levofloxacin</c:v>
                </c:pt>
                <c:pt idx="8">
                  <c:v>Linezolid</c:v>
                </c:pt>
                <c:pt idx="9">
                  <c:v>Meropenem</c:v>
                </c:pt>
                <c:pt idx="10">
                  <c:v>Piperacillin</c:v>
                </c:pt>
                <c:pt idx="11">
                  <c:v>Teicoplanin</c:v>
                </c:pt>
                <c:pt idx="12">
                  <c:v>Vancomycin</c:v>
                </c:pt>
              </c:strCache>
            </c:str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35</c:v>
                </c:pt>
                <c:pt idx="1">
                  <c:v>122</c:v>
                </c:pt>
                <c:pt idx="2">
                  <c:v>21</c:v>
                </c:pt>
                <c:pt idx="3">
                  <c:v>34</c:v>
                </c:pt>
                <c:pt idx="4">
                  <c:v>98</c:v>
                </c:pt>
                <c:pt idx="5">
                  <c:v>13</c:v>
                </c:pt>
                <c:pt idx="6">
                  <c:v>92</c:v>
                </c:pt>
                <c:pt idx="7">
                  <c:v>32</c:v>
                </c:pt>
                <c:pt idx="8">
                  <c:v>34</c:v>
                </c:pt>
                <c:pt idx="9">
                  <c:v>54</c:v>
                </c:pt>
                <c:pt idx="10">
                  <c:v>45</c:v>
                </c:pt>
                <c:pt idx="11">
                  <c:v>10</c:v>
                </c:pt>
                <c:pt idx="12">
                  <c:v>1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97-417B-897D-67D4325FCB2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elected articl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14</c:f>
              <c:strCache>
                <c:ptCount val="13"/>
                <c:pt idx="0">
                  <c:v>Amikacin</c:v>
                </c:pt>
                <c:pt idx="1">
                  <c:v>Ampicillin</c:v>
                </c:pt>
                <c:pt idx="2">
                  <c:v>Cefepime</c:v>
                </c:pt>
                <c:pt idx="3">
                  <c:v>Ceftazidime</c:v>
                </c:pt>
                <c:pt idx="4">
                  <c:v>Ciprofloxacin</c:v>
                </c:pt>
                <c:pt idx="5">
                  <c:v>Daptomycin</c:v>
                </c:pt>
                <c:pt idx="6">
                  <c:v>Gentamicin</c:v>
                </c:pt>
                <c:pt idx="7">
                  <c:v>Levofloxacin</c:v>
                </c:pt>
                <c:pt idx="8">
                  <c:v>Linezolid</c:v>
                </c:pt>
                <c:pt idx="9">
                  <c:v>Meropenem</c:v>
                </c:pt>
                <c:pt idx="10">
                  <c:v>Piperacillin</c:v>
                </c:pt>
                <c:pt idx="11">
                  <c:v>Teicoplanin</c:v>
                </c:pt>
                <c:pt idx="12">
                  <c:v>Vancomycin</c:v>
                </c:pt>
              </c:strCache>
            </c:str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</c:v>
                </c:pt>
                <c:pt idx="1">
                  <c:v>4</c:v>
                </c:pt>
                <c:pt idx="2">
                  <c:v>13</c:v>
                </c:pt>
                <c:pt idx="3">
                  <c:v>14</c:v>
                </c:pt>
                <c:pt idx="4">
                  <c:v>17</c:v>
                </c:pt>
                <c:pt idx="5">
                  <c:v>6</c:v>
                </c:pt>
                <c:pt idx="6">
                  <c:v>11</c:v>
                </c:pt>
                <c:pt idx="7">
                  <c:v>12</c:v>
                </c:pt>
                <c:pt idx="8">
                  <c:v>16</c:v>
                </c:pt>
                <c:pt idx="9">
                  <c:v>29</c:v>
                </c:pt>
                <c:pt idx="10">
                  <c:v>23</c:v>
                </c:pt>
                <c:pt idx="11">
                  <c:v>4</c:v>
                </c:pt>
                <c:pt idx="12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A97-417B-897D-67D4325FCB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5850448"/>
        <c:axId val="755851408"/>
      </c:barChart>
      <c:catAx>
        <c:axId val="755850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100" baseline="0" dirty="0">
                    <a:solidFill>
                      <a:sysClr val="windowText" lastClr="000000"/>
                    </a:solidFill>
                  </a:rPr>
                  <a:t>Drug </a:t>
                </a:r>
                <a:r>
                  <a:rPr lang="it-IT" sz="1100" baseline="0" dirty="0" err="1">
                    <a:solidFill>
                      <a:sysClr val="windowText" lastClr="000000"/>
                    </a:solidFill>
                  </a:rPr>
                  <a:t>searched</a:t>
                </a:r>
                <a:r>
                  <a:rPr lang="it-IT" sz="1100" baseline="0" dirty="0">
                    <a:solidFill>
                      <a:sysClr val="windowText" lastClr="000000"/>
                    </a:solidFill>
                  </a:rPr>
                  <a:t> in PubMed databas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55851408"/>
        <c:crosses val="autoZero"/>
        <c:auto val="1"/>
        <c:lblAlgn val="ctr"/>
        <c:lblOffset val="100"/>
        <c:noMultiLvlLbl val="0"/>
      </c:catAx>
      <c:valAx>
        <c:axId val="755851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100" baseline="0">
                    <a:solidFill>
                      <a:sysClr val="windowText" lastClr="000000"/>
                    </a:solidFill>
                  </a:rPr>
                  <a:t>N° of articl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755850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964912994892704"/>
          <c:y val="0.89678719020775932"/>
          <c:w val="0.45978411602772223"/>
          <c:h val="5.50589999784257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2136599-2B6E-193E-E9A1-2F39713120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2FEF31E-6813-9E37-8305-FCB45A96FF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BE5E0F3-188D-A638-7A37-29C3AC2BE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AEDC7B-A834-2DB5-E2A7-3A2C1BE43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CD19E8-EC51-D7D7-A1B7-163411576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3532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D25098-E0A1-CB5D-A651-2A3FFE2CFD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92D45EA-9D39-0A91-735E-8927F21336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BB5DCAA-E168-9ADD-853C-AEB7EF84C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DF7AEB9-4FC3-FF96-9F74-234BBBC15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3423D1-D9C0-ACE7-AB01-DEB115941A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5349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A1BEE8C-EA97-0D52-9ADB-284130405B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7B3A2F2-8A44-055F-1254-5BA6DCBD7E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CCFCAB6-144E-6350-0CC9-0FF1D5E67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A9CEC72-0CEA-21AF-4FDB-F22D4EA8F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162AE35-B4EB-0DB1-D190-14D73D82F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030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D19BD0-68FB-F8F1-6010-946B3EBAF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435A9AE-B7D0-84D7-F885-1AC747EEAC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5B1AF8-9F30-188B-D736-0FC9BC511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87AF9E3-18A9-3AEE-2444-63DFBC97D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8554B72-0C80-E444-6BAB-EBC49D4C9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16965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53B797-4DE1-4D4D-7063-029BD8F39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B3BD217-6F64-DBEA-2409-BB54C99B15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365C62A-FEB4-D500-45DC-375BAF039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5F4E30-C98D-6F4E-44E2-795CE6022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327729-9445-5C95-C7B8-A1C235CEC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9984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0051F94-8288-F672-A0C3-581A2A913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0EE3409-0B04-39BB-69C0-4C84C0A50B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D9AD72B-FC4F-E1DB-77CD-EFB1799131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E1293E3-06D4-D268-1E88-A239D0AE1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0EBC03E-2FEC-0654-E919-264094566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2A5BA65-EA58-F8E3-DBF0-1850CC4C2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4829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86ECD1-BE26-1A8B-82D1-EBE6DFFB6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2337085-3E9E-F6FD-F328-E14DC9702C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7130DB2-3A75-07F8-D5C7-66974D652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5B2304E4-BD51-8B66-829E-BDA996E4E7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1D81BEA-9A28-772D-61A4-578B985504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29B4ED1-73CF-EB0B-0EE6-2CD68D00F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1EE8A2C-9DC6-7CF1-FE5C-F8B30256C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0F4C6C5-72AE-FD25-4905-092F057F0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145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84361F3-F92A-A2E8-1123-CF772A1AF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B641A35-C97C-3372-20F0-2DE5E3583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15DDA50-FB27-BC20-F19C-41A55C54C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3C9F11D-DBC2-192B-5DC2-EC7F6A180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7768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A35B271-3596-A692-2D58-1C786EF717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A0BA11E-2EB2-3F4D-60F2-50E79307F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61A6741-95E3-8C22-A41A-C6CA7E294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131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DAD56F-7A33-80FA-69C7-A08FE6E2B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3E55B3E-8E95-5518-4734-29F5D21662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8237C18-2F4E-3938-4EC8-DA5D11CD1E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8607EB-687B-570B-0430-150C7CEC8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E387E67-34AC-60CD-5588-F00A27230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C433E0F-672A-8C88-D987-B15BB514D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765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E6E8D61-A74C-65C4-C4C7-B061C1487A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B9BA090-D17C-5362-E3E5-7D2AE38B06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77F1593-F94B-B8A3-122A-D4E1FE99E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163B074-DCAC-767C-658A-A940E4DA9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306AE7F-7818-2D06-41C0-CE7AE4491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98FCBC0-31BA-9028-CFEE-CA877025B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0866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501AA54-F520-1352-EC44-7F00312B4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66FAC45-ED21-59D0-2DD9-C50288765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AD12D5-A700-1185-30FD-A85C976067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CD3CA9-583C-447F-8D50-4203921BBED6}" type="datetimeFigureOut">
              <a:rPr lang="it-IT" smtClean="0"/>
              <a:t>16/07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AECCB15-5956-8D55-93B9-B5998BDA65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BD06585-13AF-B528-05C1-CEF7C4F0CF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DDC92D-2106-4A7E-82E9-ACD148CF5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786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7899B123-D32B-0133-3350-61509E2D4ABE}"/>
              </a:ext>
            </a:extLst>
          </p:cNvPr>
          <p:cNvSpPr txBox="1"/>
          <p:nvPr/>
        </p:nvSpPr>
        <p:spPr>
          <a:xfrm>
            <a:off x="4485740" y="106291"/>
            <a:ext cx="29058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Initial research on PubMed</a:t>
            </a:r>
          </a:p>
        </p:txBody>
      </p:sp>
      <p:cxnSp>
        <p:nvCxnSpPr>
          <p:cNvPr id="9" name="Connettore 2 8">
            <a:extLst>
              <a:ext uri="{FF2B5EF4-FFF2-40B4-BE49-F238E27FC236}">
                <a16:creationId xmlns:a16="http://schemas.microsoft.com/office/drawing/2014/main" id="{6FA73DA0-7465-395B-00DE-6B00226F234A}"/>
              </a:ext>
            </a:extLst>
          </p:cNvPr>
          <p:cNvCxnSpPr>
            <a:cxnSpLocks/>
          </p:cNvCxnSpPr>
          <p:nvPr/>
        </p:nvCxnSpPr>
        <p:spPr>
          <a:xfrm flipH="1">
            <a:off x="5938674" y="499112"/>
            <a:ext cx="1" cy="285136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" name="Terminatore 10">
            <a:extLst>
              <a:ext uri="{FF2B5EF4-FFF2-40B4-BE49-F238E27FC236}">
                <a16:creationId xmlns:a16="http://schemas.microsoft.com/office/drawing/2014/main" id="{B5EA0437-BC23-9E16-EAAE-3CBB62832D5D}"/>
              </a:ext>
            </a:extLst>
          </p:cNvPr>
          <p:cNvSpPr/>
          <p:nvPr/>
        </p:nvSpPr>
        <p:spPr>
          <a:xfrm>
            <a:off x="4788292" y="75513"/>
            <a:ext cx="2300766" cy="369332"/>
          </a:xfrm>
          <a:prstGeom prst="flowChartTerminator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F7C63D3-B339-E6BB-9131-A23CC8CF983A}"/>
              </a:ext>
            </a:extLst>
          </p:cNvPr>
          <p:cNvSpPr txBox="1"/>
          <p:nvPr/>
        </p:nvSpPr>
        <p:spPr>
          <a:xfrm>
            <a:off x="5192668" y="811740"/>
            <a:ext cx="14920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/>
              <a:t>700 article found</a:t>
            </a: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B6BD1A6F-6B45-354E-EC09-BB95D3413F13}"/>
              </a:ext>
            </a:extLst>
          </p:cNvPr>
          <p:cNvSpPr/>
          <p:nvPr/>
        </p:nvSpPr>
        <p:spPr>
          <a:xfrm>
            <a:off x="5192669" y="826912"/>
            <a:ext cx="1492010" cy="261912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6" name="Connettore 2 15">
            <a:extLst>
              <a:ext uri="{FF2B5EF4-FFF2-40B4-BE49-F238E27FC236}">
                <a16:creationId xmlns:a16="http://schemas.microsoft.com/office/drawing/2014/main" id="{81DF99C0-EADE-F513-D704-A6F6B172E288}"/>
              </a:ext>
            </a:extLst>
          </p:cNvPr>
          <p:cNvCxnSpPr>
            <a:cxnSpLocks/>
          </p:cNvCxnSpPr>
          <p:nvPr/>
        </p:nvCxnSpPr>
        <p:spPr>
          <a:xfrm flipH="1">
            <a:off x="5938667" y="1158496"/>
            <a:ext cx="7" cy="34197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17" name="Grafico 16">
            <a:extLst>
              <a:ext uri="{FF2B5EF4-FFF2-40B4-BE49-F238E27FC236}">
                <a16:creationId xmlns:a16="http://schemas.microsoft.com/office/drawing/2014/main" id="{A643EE7A-F6B8-C964-397F-DAF4F552B3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5752715"/>
              </p:ext>
            </p:extLst>
          </p:nvPr>
        </p:nvGraphicFramePr>
        <p:xfrm>
          <a:off x="3101448" y="1547798"/>
          <a:ext cx="5674437" cy="37155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85BC2180-F219-71E7-7798-E04E96E0D191}"/>
              </a:ext>
            </a:extLst>
          </p:cNvPr>
          <p:cNvSpPr txBox="1"/>
          <p:nvPr/>
        </p:nvSpPr>
        <p:spPr>
          <a:xfrm>
            <a:off x="3852899" y="6041920"/>
            <a:ext cx="428685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/>
              <a:t>172 article with data on stability selected. </a:t>
            </a:r>
            <a:r>
              <a:rPr lang="en-US" sz="1400" b="1" u="sng" dirty="0"/>
              <a:t>103</a:t>
            </a:r>
            <a:r>
              <a:rPr lang="en-US" sz="1400" dirty="0"/>
              <a:t> unique articles (many articles cover more than one drug in the study)</a:t>
            </a:r>
            <a:endParaRPr lang="it-IT" sz="1400" dirty="0"/>
          </a:p>
        </p:txBody>
      </p:sp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1C185DE5-0FC3-1EC0-5F47-E63A24C3D1AE}"/>
              </a:ext>
            </a:extLst>
          </p:cNvPr>
          <p:cNvCxnSpPr>
            <a:cxnSpLocks/>
          </p:cNvCxnSpPr>
          <p:nvPr/>
        </p:nvCxnSpPr>
        <p:spPr>
          <a:xfrm>
            <a:off x="5938667" y="5233066"/>
            <a:ext cx="0" cy="614355"/>
          </a:xfrm>
          <a:prstGeom prst="straightConnector1">
            <a:avLst/>
          </a:prstGeom>
          <a:ln w="3810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1" name="Terminatore 30">
            <a:extLst>
              <a:ext uri="{FF2B5EF4-FFF2-40B4-BE49-F238E27FC236}">
                <a16:creationId xmlns:a16="http://schemas.microsoft.com/office/drawing/2014/main" id="{246028CE-FAAD-871B-2E8F-2E202F3DDFB9}"/>
              </a:ext>
            </a:extLst>
          </p:cNvPr>
          <p:cNvSpPr/>
          <p:nvPr/>
        </p:nvSpPr>
        <p:spPr>
          <a:xfrm>
            <a:off x="3852899" y="5918233"/>
            <a:ext cx="4286858" cy="811557"/>
          </a:xfrm>
          <a:prstGeom prst="flowChartTerminator">
            <a:avLst/>
          </a:prstGeom>
          <a:noFill/>
          <a:ln w="381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Rettangolo 32">
            <a:extLst>
              <a:ext uri="{FF2B5EF4-FFF2-40B4-BE49-F238E27FC236}">
                <a16:creationId xmlns:a16="http://schemas.microsoft.com/office/drawing/2014/main" id="{9FA8B7BE-2FAB-7C05-1C0B-49E2D56485FC}"/>
              </a:ext>
            </a:extLst>
          </p:cNvPr>
          <p:cNvSpPr/>
          <p:nvPr/>
        </p:nvSpPr>
        <p:spPr>
          <a:xfrm>
            <a:off x="3233467" y="1555256"/>
            <a:ext cx="5468078" cy="3606998"/>
          </a:xfrm>
          <a:prstGeom prst="rect">
            <a:avLst/>
          </a:prstGeom>
          <a:noFill/>
          <a:ln w="3810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38497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3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LLA ZUANNA PAOLO [SST0200011]</dc:creator>
  <cp:lastModifiedBy>DALLA ZUANNA PAOLO [SST0200011]</cp:lastModifiedBy>
  <cp:revision>2</cp:revision>
  <dcterms:created xsi:type="dcterms:W3CDTF">2024-07-15T19:57:44Z</dcterms:created>
  <dcterms:modified xsi:type="dcterms:W3CDTF">2024-07-16T16:00:54Z</dcterms:modified>
</cp:coreProperties>
</file>